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3"/>
    <p:restoredTop sz="91411"/>
  </p:normalViewPr>
  <p:slideViewPr>
    <p:cSldViewPr snapToGrid="0" snapToObjects="1" showGuides="1">
      <p:cViewPr>
        <p:scale>
          <a:sx n="69" d="100"/>
          <a:sy n="69" d="100"/>
        </p:scale>
        <p:origin x="1576" y="21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66F1C-1931-7F46-BC9E-62ED967BE985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6B9EF4-5932-9249-BB5B-5EA49DD10CA3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9023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/>
              <a:t>Supplementary Figure 1. 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6B9EF4-5932-9249-BB5B-5EA49DD10CA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007038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4FC37D7-4041-844D-B948-EDBEED80E3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2EF7B9C-8E3F-1743-813B-C4634D9886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CA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43AFA2B-AC49-7049-9A60-880D37140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A53DF98-713B-7940-8853-CA5B1C34C2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3393069-6A87-6B48-9248-69638FD31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47571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F796D7-8FAD-9448-8D9D-B3BC9FBC9C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D606974-8B1C-1A45-9D0E-B84A8624E6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A5A7E3D-49BA-BA43-8506-1350F4C74A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350FD34-0397-7646-B9AC-627A5A566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5517CCA-8851-BF48-959C-57A1C04BA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3497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94586E1-AA1B-8948-98E9-C661145652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97A1B6C-582D-7E4A-8F9C-EB826DE1C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79C881F-E8D6-9045-8D4C-DB9D5B3BA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D331F0-0795-A249-9D65-C5E1A9895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0D33B4E-B6EB-094A-8FD6-2FC58BB33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82216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9AC8841-D554-B84C-B631-0DD216D33D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08B6470-FE9E-5345-ACC8-052B9E7CA7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A545FE6-367B-4E49-B9DA-12CC45785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D0DD9FF-D46D-0C4E-B6D8-40C2F8AAD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ECB1848-1D66-A84C-A5A8-0A45B82EA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32437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4AC395-0E60-5248-ACCC-CCAF3F58E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BDCF639-C6A4-A64C-8B74-4B2DD602AB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C8292D7-7F64-E840-9BE5-9ABA60B85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D678BB4-9B82-094F-959A-6FA98E202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8FC7109-B6AD-D948-BA1E-87CDE4869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88299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69360A8-B5BB-8A4D-BC39-2577335ABE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D70C2EF-E2A6-844F-A21B-88164B275A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1C84ACF-2B60-FF48-B250-99388B10C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625D980-0669-3144-AE44-D51619A81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2F959DD-F152-0843-B7AC-CA54063DD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C27CA05-F689-4046-A7E5-FC0F2E82B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1471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6FF36CF-4419-CA46-AD0A-E17630633C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089496A-4593-0E46-BB45-E97F7ED169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447C322-08D1-2D44-B5A7-AC22F256B8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85EE2A2-0A30-E449-997D-F2F69849FF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01D8769E-B7EF-864B-9A50-2947F69C91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BAEBEFA-BF92-E744-A931-00CA217F0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B325B392-F271-7C47-8FA1-792CE8DEF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BC560C2-4DFB-3943-8157-EE0F6224D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82872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CCA9BFA-7C58-9A4C-B2A2-BCD5FA2DF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F86A4E7-29D4-E24B-B16A-70332C59E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FAC0B715-21F6-A243-ABB5-16EB5ADD0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879F488-8A43-044D-99E1-552A94C53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89409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66BD0E26-626A-2D47-B00D-7B82038B6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2BF537-891A-614A-BCC7-BF6A9E199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01D70567-14D9-7040-83F9-C92248677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55663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79A21CD-2C91-7445-BEF4-3F4927258D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9B144BB-CE30-5B47-A194-72E0C709B8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D8EE6FC-9892-DB48-A2B5-A099AC5400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3D8939A-7DAE-D84D-AC04-40B507C9E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A524085-7B94-4F4B-80A7-B5BDD79BA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C824411-CB7E-DB49-8D0B-36142B66F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94881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18BB600-EDF5-C441-84F9-2B21DCF0C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054F618-DB54-E144-A63C-CB237A8422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3C212DE-A803-F24B-AD40-CC1EE8F761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A58959E-4117-E747-AF61-2D955B8C2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9B65A8E-362F-0144-ACA0-F3B776F2E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465E622-61C9-E14E-80D4-01ADB4EAD6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0308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826726A-FBF0-4A4C-A3E2-EBE4ED77F6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CA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6FE69E1-5A25-3A4A-A6C7-438C0EB4F4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it-IT"/>
              <a:t>Modifica gli stili del testo dello schema
Secondo livello
Terzo livello
Quarto livello
Quinto livello</a:t>
            </a:r>
            <a:endParaRPr lang="en-CA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C23B6B8-85EC-B340-9C74-D0C2303AC1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CEB69-5AEA-794B-B4F2-EA6DBA3F65E4}" type="datetimeFigureOut">
              <a:rPr lang="en-CA" smtClean="0"/>
              <a:t>2022-10-03</a:t>
            </a:fld>
            <a:endParaRPr lang="en-CA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7A83B4A-E92A-8848-AABE-B021BE72E8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6D76EB2-0DD1-C141-AD63-7A5B37B5AC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2A911-8C6E-044E-9B0B-886A2BA6C8E9}" type="slidenum">
              <a:rPr lang="en-CA" smtClean="0"/>
              <a:t>‹N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3259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magine 40">
            <a:extLst>
              <a:ext uri="{FF2B5EF4-FFF2-40B4-BE49-F238E27FC236}">
                <a16:creationId xmlns:a16="http://schemas.microsoft.com/office/drawing/2014/main" id="{316A0608-C286-2244-8318-AC909788C1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34738" y="320037"/>
            <a:ext cx="5224533" cy="3353793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FDB56F3C-2FA0-3843-A0FB-7427675ED8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1736" y="234950"/>
            <a:ext cx="5099050" cy="3194050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AF13661F-21DF-CF4B-9D84-8DA0DF762412}"/>
              </a:ext>
            </a:extLst>
          </p:cNvPr>
          <p:cNvSpPr txBox="1"/>
          <p:nvPr/>
        </p:nvSpPr>
        <p:spPr>
          <a:xfrm>
            <a:off x="1324601" y="3042393"/>
            <a:ext cx="4193328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/>
              <a:t>Controls              Normo-PRL FSD       Hyper-PRL FSD</a:t>
            </a:r>
          </a:p>
          <a:p>
            <a:r>
              <a:rPr lang="en-CA" sz="1400" dirty="0"/>
              <a:t> 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1FBB6AEA-A239-A04A-8C3B-D67FEF35E3DD}"/>
              </a:ext>
            </a:extLst>
          </p:cNvPr>
          <p:cNvSpPr txBox="1"/>
          <p:nvPr/>
        </p:nvSpPr>
        <p:spPr>
          <a:xfrm>
            <a:off x="7378562" y="3026626"/>
            <a:ext cx="4193328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/>
              <a:t>Controls              Normo-PRL FSD       Hyper-PRL FSD</a:t>
            </a:r>
          </a:p>
          <a:p>
            <a:r>
              <a:rPr lang="en-CA" sz="1400" dirty="0"/>
              <a:t> 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74BE7169-0B2F-4C4F-8235-F6E3B916EC61}"/>
              </a:ext>
            </a:extLst>
          </p:cNvPr>
          <p:cNvSpPr txBox="1"/>
          <p:nvPr/>
        </p:nvSpPr>
        <p:spPr>
          <a:xfrm rot="16200000">
            <a:off x="-867247" y="1580267"/>
            <a:ext cx="255345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95% CI FSFI Desire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2AD29E58-D0A0-0947-AA05-6B2B4E985E2F}"/>
              </a:ext>
            </a:extLst>
          </p:cNvPr>
          <p:cNvSpPr txBox="1"/>
          <p:nvPr/>
        </p:nvSpPr>
        <p:spPr>
          <a:xfrm rot="16200000">
            <a:off x="5099204" y="1580266"/>
            <a:ext cx="255345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95% CI FSFI Desire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3F08B18-0573-174C-B59A-A22F93E9259C}"/>
              </a:ext>
            </a:extLst>
          </p:cNvPr>
          <p:cNvSpPr txBox="1"/>
          <p:nvPr/>
        </p:nvSpPr>
        <p:spPr>
          <a:xfrm>
            <a:off x="1483744" y="135577"/>
            <a:ext cx="32739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dirty="0"/>
              <a:t>Pre-menopausal women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23C51732-48B0-3D48-BA22-97436A9CCC2D}"/>
              </a:ext>
            </a:extLst>
          </p:cNvPr>
          <p:cNvSpPr txBox="1"/>
          <p:nvPr/>
        </p:nvSpPr>
        <p:spPr>
          <a:xfrm>
            <a:off x="7421291" y="135371"/>
            <a:ext cx="327397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dirty="0"/>
              <a:t>Post-menopausal women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D1631DA-AAF5-104D-8399-4208224D4524}"/>
              </a:ext>
            </a:extLst>
          </p:cNvPr>
          <p:cNvSpPr txBox="1"/>
          <p:nvPr/>
        </p:nvSpPr>
        <p:spPr>
          <a:xfrm>
            <a:off x="3795474" y="578089"/>
            <a:ext cx="1535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400" dirty="0" err="1"/>
              <a:t>F</a:t>
            </a:r>
            <a:r>
              <a:rPr lang="it-IT" sz="1400" dirty="0"/>
              <a:t>=42.008, </a:t>
            </a:r>
            <a:r>
              <a:rPr lang="it-IT" sz="1400" dirty="0" err="1"/>
              <a:t>p</a:t>
            </a:r>
            <a:r>
              <a:rPr lang="it-IT" sz="1400" dirty="0"/>
              <a:t>&lt;0.001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7BC44F08-2A78-CA45-94E0-4930DA784B10}"/>
              </a:ext>
            </a:extLst>
          </p:cNvPr>
          <p:cNvSpPr txBox="1"/>
          <p:nvPr/>
        </p:nvSpPr>
        <p:spPr>
          <a:xfrm>
            <a:off x="10085926" y="590564"/>
            <a:ext cx="1535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400" dirty="0" err="1"/>
              <a:t>F</a:t>
            </a:r>
            <a:r>
              <a:rPr lang="it-IT" sz="1400" dirty="0"/>
              <a:t>=26.983, </a:t>
            </a:r>
            <a:r>
              <a:rPr lang="it-IT" sz="1400" dirty="0" err="1"/>
              <a:t>p</a:t>
            </a:r>
            <a:r>
              <a:rPr lang="it-IT" sz="1400" dirty="0"/>
              <a:t>&lt;0.001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A5D56A85-CD1F-A046-A4AC-9131968558E0}"/>
              </a:ext>
            </a:extLst>
          </p:cNvPr>
          <p:cNvSpPr txBox="1"/>
          <p:nvPr/>
        </p:nvSpPr>
        <p:spPr>
          <a:xfrm>
            <a:off x="777318" y="168442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537A566-A41E-9B48-9C83-380CBF5EA7BA}"/>
              </a:ext>
            </a:extLst>
          </p:cNvPr>
          <p:cNvSpPr txBox="1"/>
          <p:nvPr/>
        </p:nvSpPr>
        <p:spPr>
          <a:xfrm>
            <a:off x="1364935" y="3023022"/>
            <a:ext cx="4193328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/>
              <a:t>Controls              Normo-PRL FSD       Hyper-PRL FSD</a:t>
            </a:r>
          </a:p>
          <a:p>
            <a:r>
              <a:rPr lang="en-CA" sz="1400" dirty="0"/>
              <a:t> </a:t>
            </a:r>
          </a:p>
        </p:txBody>
      </p:sp>
      <p:grpSp>
        <p:nvGrpSpPr>
          <p:cNvPr id="20" name="Gruppo 19">
            <a:extLst>
              <a:ext uri="{FF2B5EF4-FFF2-40B4-BE49-F238E27FC236}">
                <a16:creationId xmlns:a16="http://schemas.microsoft.com/office/drawing/2014/main" id="{77BA45FA-D060-714D-B6E8-560175282465}"/>
              </a:ext>
            </a:extLst>
          </p:cNvPr>
          <p:cNvGrpSpPr/>
          <p:nvPr/>
        </p:nvGrpSpPr>
        <p:grpSpPr>
          <a:xfrm>
            <a:off x="234132" y="3357359"/>
            <a:ext cx="5975131" cy="3831728"/>
            <a:chOff x="234132" y="3026273"/>
            <a:chExt cx="5975131" cy="3831728"/>
          </a:xfrm>
        </p:grpSpPr>
        <p:pic>
          <p:nvPicPr>
            <p:cNvPr id="16" name="Immagine 15">
              <a:extLst>
                <a:ext uri="{FF2B5EF4-FFF2-40B4-BE49-F238E27FC236}">
                  <a16:creationId xmlns:a16="http://schemas.microsoft.com/office/drawing/2014/main" id="{AEEFF485-80FF-ED43-9BC3-7592DF0559B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0204" y="3026273"/>
              <a:ext cx="5969059" cy="3831728"/>
            </a:xfrm>
            <a:prstGeom prst="rect">
              <a:avLst/>
            </a:prstGeom>
          </p:spPr>
        </p:pic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4F61F5AD-629C-474A-A1E9-0B2A48809C18}"/>
                </a:ext>
              </a:extLst>
            </p:cNvPr>
            <p:cNvSpPr txBox="1"/>
            <p:nvPr/>
          </p:nvSpPr>
          <p:spPr>
            <a:xfrm rot="16200000">
              <a:off x="-873320" y="4504360"/>
              <a:ext cx="2553457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600" dirty="0"/>
                <a:t>95% CI FSFI Satisfaction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E792768B-7060-8641-9566-214A3BEE8D19}"/>
                </a:ext>
              </a:extLst>
            </p:cNvPr>
            <p:cNvSpPr txBox="1"/>
            <p:nvPr/>
          </p:nvSpPr>
          <p:spPr>
            <a:xfrm>
              <a:off x="1483744" y="6072704"/>
              <a:ext cx="4612256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CA" sz="1400" dirty="0"/>
                <a:t>Controls                  Normo-PRL FSD              Hyper-PRL FSD</a:t>
              </a:r>
            </a:p>
            <a:p>
              <a:r>
                <a:rPr lang="en-CA" sz="1400" dirty="0"/>
                <a:t> </a:t>
              </a:r>
            </a:p>
          </p:txBody>
        </p:sp>
      </p:grp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BA05F265-82B6-5B4F-9BF1-EDB36DE87359}"/>
              </a:ext>
            </a:extLst>
          </p:cNvPr>
          <p:cNvSpPr txBox="1"/>
          <p:nvPr/>
        </p:nvSpPr>
        <p:spPr>
          <a:xfrm>
            <a:off x="779646" y="3412180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B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6C848F3F-4F82-5746-9454-11391F36914C}"/>
              </a:ext>
            </a:extLst>
          </p:cNvPr>
          <p:cNvSpPr txBox="1"/>
          <p:nvPr/>
        </p:nvSpPr>
        <p:spPr>
          <a:xfrm>
            <a:off x="2475313" y="3307949"/>
            <a:ext cx="201798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pic>
        <p:nvPicPr>
          <p:cNvPr id="22" name="Immagine 21">
            <a:extLst>
              <a:ext uri="{FF2B5EF4-FFF2-40B4-BE49-F238E27FC236}">
                <a16:creationId xmlns:a16="http://schemas.microsoft.com/office/drawing/2014/main" id="{0ADEF0F1-4E27-854B-8F25-EEA03F03AD1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01410" y="3324288"/>
            <a:ext cx="5974122" cy="3834978"/>
          </a:xfrm>
          <a:prstGeom prst="rect">
            <a:avLst/>
          </a:prstGeom>
        </p:spPr>
      </p:pic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1D8200DF-D9E1-2149-AC96-F0A6BD64C2FB}"/>
              </a:ext>
            </a:extLst>
          </p:cNvPr>
          <p:cNvSpPr txBox="1"/>
          <p:nvPr/>
        </p:nvSpPr>
        <p:spPr>
          <a:xfrm>
            <a:off x="7427698" y="6389347"/>
            <a:ext cx="4629508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CA" sz="1400" dirty="0"/>
              <a:t>Controls                     Normo-PRL FSD           Hyper-PRL FSD</a:t>
            </a:r>
          </a:p>
          <a:p>
            <a:r>
              <a:rPr lang="en-CA" sz="1400" dirty="0"/>
              <a:t> </a:t>
            </a:r>
          </a:p>
        </p:txBody>
      </p:sp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464B3316-AF9E-C548-8C86-588A8D2C708F}"/>
              </a:ext>
            </a:extLst>
          </p:cNvPr>
          <p:cNvSpPr txBox="1"/>
          <p:nvPr/>
        </p:nvSpPr>
        <p:spPr>
          <a:xfrm>
            <a:off x="8183404" y="3284632"/>
            <a:ext cx="201798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CA" dirty="0"/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03DA0A13-7C87-A640-BDAE-1E722B8F0684}"/>
              </a:ext>
            </a:extLst>
          </p:cNvPr>
          <p:cNvSpPr txBox="1"/>
          <p:nvPr/>
        </p:nvSpPr>
        <p:spPr>
          <a:xfrm rot="16200000">
            <a:off x="5046264" y="4784733"/>
            <a:ext cx="255345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CA" sz="1600" dirty="0"/>
              <a:t>95% CI FSFI Satisfaction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048B8C9A-B6A9-1944-A859-7B1165F5862C}"/>
              </a:ext>
            </a:extLst>
          </p:cNvPr>
          <p:cNvSpPr txBox="1"/>
          <p:nvPr/>
        </p:nvSpPr>
        <p:spPr>
          <a:xfrm>
            <a:off x="6779040" y="208757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C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CC563CFF-46C0-214D-B98F-727D369E9824}"/>
              </a:ext>
            </a:extLst>
          </p:cNvPr>
          <p:cNvSpPr txBox="1"/>
          <p:nvPr/>
        </p:nvSpPr>
        <p:spPr>
          <a:xfrm>
            <a:off x="6774920" y="3468656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D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9774F9FE-96B1-3A4F-8873-6DD12321AFB3}"/>
              </a:ext>
            </a:extLst>
          </p:cNvPr>
          <p:cNvSpPr txBox="1"/>
          <p:nvPr/>
        </p:nvSpPr>
        <p:spPr>
          <a:xfrm>
            <a:off x="3795474" y="3707319"/>
            <a:ext cx="1535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400" dirty="0" err="1"/>
              <a:t>F</a:t>
            </a:r>
            <a:r>
              <a:rPr lang="it-IT" sz="1400" dirty="0"/>
              <a:t>=21.441, </a:t>
            </a:r>
            <a:r>
              <a:rPr lang="it-IT" sz="1400" dirty="0" err="1"/>
              <a:t>p</a:t>
            </a:r>
            <a:r>
              <a:rPr lang="it-IT" sz="1400" dirty="0"/>
              <a:t>&lt;0.001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C172C08A-C029-E048-A8C2-45A9A9E04E9C}"/>
              </a:ext>
            </a:extLst>
          </p:cNvPr>
          <p:cNvSpPr txBox="1"/>
          <p:nvPr/>
        </p:nvSpPr>
        <p:spPr>
          <a:xfrm>
            <a:off x="10074328" y="3677281"/>
            <a:ext cx="1535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400" dirty="0" err="1"/>
              <a:t>F</a:t>
            </a:r>
            <a:r>
              <a:rPr lang="it-IT" sz="1400" dirty="0"/>
              <a:t>=13.856, </a:t>
            </a:r>
            <a:r>
              <a:rPr lang="it-IT" sz="1400" dirty="0" err="1"/>
              <a:t>p</a:t>
            </a:r>
            <a:r>
              <a:rPr lang="it-IT" sz="1400" dirty="0"/>
              <a:t>&lt;0.001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A7D6D01B-CC1E-7C44-992C-C1650BB1B3EA}"/>
              </a:ext>
            </a:extLst>
          </p:cNvPr>
          <p:cNvSpPr txBox="1"/>
          <p:nvPr/>
        </p:nvSpPr>
        <p:spPr>
          <a:xfrm>
            <a:off x="1489893" y="459177"/>
            <a:ext cx="403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*°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45A31131-C431-E44A-81E4-B351E4E4D411}"/>
              </a:ext>
            </a:extLst>
          </p:cNvPr>
          <p:cNvSpPr txBox="1"/>
          <p:nvPr/>
        </p:nvSpPr>
        <p:spPr>
          <a:xfrm>
            <a:off x="2918994" y="1621237"/>
            <a:ext cx="403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°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217EE589-DDB0-6D46-A38E-0A9A190CA903}"/>
              </a:ext>
            </a:extLst>
          </p:cNvPr>
          <p:cNvSpPr txBox="1"/>
          <p:nvPr/>
        </p:nvSpPr>
        <p:spPr>
          <a:xfrm>
            <a:off x="7461915" y="542025"/>
            <a:ext cx="403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*°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B476C4E6-3508-F44C-B63A-C92B0B6D74F0}"/>
              </a:ext>
            </a:extLst>
          </p:cNvPr>
          <p:cNvSpPr txBox="1"/>
          <p:nvPr/>
        </p:nvSpPr>
        <p:spPr>
          <a:xfrm>
            <a:off x="1660954" y="3578712"/>
            <a:ext cx="403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*°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289105AE-66E3-6A49-A245-254F8851B489}"/>
              </a:ext>
            </a:extLst>
          </p:cNvPr>
          <p:cNvSpPr txBox="1"/>
          <p:nvPr/>
        </p:nvSpPr>
        <p:spPr>
          <a:xfrm>
            <a:off x="7615481" y="3529937"/>
            <a:ext cx="403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*°</a:t>
            </a: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B7BB6733-B57C-6946-B7C0-0BF1D388803E}"/>
              </a:ext>
            </a:extLst>
          </p:cNvPr>
          <p:cNvSpPr txBox="1"/>
          <p:nvPr/>
        </p:nvSpPr>
        <p:spPr>
          <a:xfrm>
            <a:off x="8922416" y="1865723"/>
            <a:ext cx="403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°</a:t>
            </a:r>
          </a:p>
        </p:txBody>
      </p:sp>
    </p:spTree>
    <p:extLst>
      <p:ext uri="{BB962C8B-B14F-4D97-AF65-F5344CB8AC3E}">
        <p14:creationId xmlns:p14="http://schemas.microsoft.com/office/powerpoint/2010/main" val="28699561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97</Words>
  <Application>Microsoft Macintosh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 di Microsoft Office</dc:creator>
  <cp:lastModifiedBy>Utente di Microsoft Office</cp:lastModifiedBy>
  <cp:revision>4</cp:revision>
  <dcterms:created xsi:type="dcterms:W3CDTF">2022-10-03T09:49:30Z</dcterms:created>
  <dcterms:modified xsi:type="dcterms:W3CDTF">2022-10-03T11:35:22Z</dcterms:modified>
</cp:coreProperties>
</file>